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14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9FCAB5-7490-4A02-B029-D55DB22308FC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629E12-F166-412C-8635-5817F530E3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9609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629E12-F166-412C-8635-5817F530E3E6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10404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E8087-8C0A-4E6A-8295-FD290DF6BD53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01375-E33E-40B4-A9B6-21C99D8E66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52477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E8087-8C0A-4E6A-8295-FD290DF6BD53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01375-E33E-40B4-A9B6-21C99D8E66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1616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E8087-8C0A-4E6A-8295-FD290DF6BD53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01375-E33E-40B4-A9B6-21C99D8E66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8798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E8087-8C0A-4E6A-8295-FD290DF6BD53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01375-E33E-40B4-A9B6-21C99D8E66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2052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E8087-8C0A-4E6A-8295-FD290DF6BD53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01375-E33E-40B4-A9B6-21C99D8E66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68796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E8087-8C0A-4E6A-8295-FD290DF6BD53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01375-E33E-40B4-A9B6-21C99D8E66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862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E8087-8C0A-4E6A-8295-FD290DF6BD53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01375-E33E-40B4-A9B6-21C99D8E66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2052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E8087-8C0A-4E6A-8295-FD290DF6BD53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01375-E33E-40B4-A9B6-21C99D8E66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99628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E8087-8C0A-4E6A-8295-FD290DF6BD53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01375-E33E-40B4-A9B6-21C99D8E66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6565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E8087-8C0A-4E6A-8295-FD290DF6BD53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01375-E33E-40B4-A9B6-21C99D8E66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3658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FE8087-8C0A-4E6A-8295-FD290DF6BD53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01375-E33E-40B4-A9B6-21C99D8E66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1227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FE8087-8C0A-4E6A-8295-FD290DF6BD53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801375-E33E-40B4-A9B6-21C99D8E66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54567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46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GB" dirty="0" smtClean="0"/>
              <a:t>Additional file 4: </a:t>
            </a:r>
            <a:r>
              <a:rPr lang="en-GB" dirty="0" smtClean="0"/>
              <a:t>data </a:t>
            </a:r>
            <a:r>
              <a:rPr lang="en-GB" dirty="0" smtClean="0"/>
              <a:t>synthesis matrix </a:t>
            </a:r>
            <a:r>
              <a:rPr lang="en-GB" dirty="0" smtClean="0"/>
              <a:t/>
            </a:r>
            <a:br>
              <a:rPr lang="en-GB" dirty="0" smtClean="0"/>
            </a:br>
            <a:r>
              <a:rPr lang="en-GB" sz="1800" dirty="0" smtClean="0"/>
              <a:t>modified from Hogarth R M (2005) The challenge of representative design in psychology and economics. Journal of economic Methodology, 12(2): 253-263</a:t>
            </a:r>
            <a:endParaRPr lang="en-GB" sz="1800" dirty="0"/>
          </a:p>
        </p:txBody>
      </p:sp>
      <p:grpSp>
        <p:nvGrpSpPr>
          <p:cNvPr id="4" name="Group 3"/>
          <p:cNvGrpSpPr/>
          <p:nvPr/>
        </p:nvGrpSpPr>
        <p:grpSpPr>
          <a:xfrm>
            <a:off x="1143000" y="1688068"/>
            <a:ext cx="5638800" cy="4865132"/>
            <a:chOff x="1676400" y="1688068"/>
            <a:chExt cx="5638800" cy="4865132"/>
          </a:xfrm>
        </p:grpSpPr>
        <p:sp>
          <p:nvSpPr>
            <p:cNvPr id="10" name="TextBox 9"/>
            <p:cNvSpPr txBox="1"/>
            <p:nvPr/>
          </p:nvSpPr>
          <p:spPr>
            <a:xfrm>
              <a:off x="2286000" y="464820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1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286000" y="3897868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2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286000" y="312420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3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286000" y="2373868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4</a:t>
              </a:r>
            </a:p>
          </p:txBody>
        </p:sp>
        <p:cxnSp>
          <p:nvCxnSpPr>
            <p:cNvPr id="17" name="Straight Connector 16"/>
            <p:cNvCxnSpPr>
              <a:endCxn id="40" idx="3"/>
            </p:cNvCxnSpPr>
            <p:nvPr/>
          </p:nvCxnSpPr>
          <p:spPr>
            <a:xfrm>
              <a:off x="2743200" y="3733800"/>
              <a:ext cx="4572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3505200" y="579120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1</a:t>
              </a:r>
              <a:endParaRPr lang="en-GB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422714" y="579120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2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337114" y="579120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3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172200" y="579120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4</a:t>
              </a:r>
            </a:p>
          </p:txBody>
        </p:sp>
        <p:cxnSp>
          <p:nvCxnSpPr>
            <p:cNvPr id="34" name="Straight Connector 33"/>
            <p:cNvCxnSpPr/>
            <p:nvPr/>
          </p:nvCxnSpPr>
          <p:spPr>
            <a:xfrm flipH="1" flipV="1">
              <a:off x="5029200" y="1752600"/>
              <a:ext cx="30133" cy="39624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Rectangle 39"/>
            <p:cNvSpPr/>
            <p:nvPr/>
          </p:nvSpPr>
          <p:spPr>
            <a:xfrm>
              <a:off x="2759136" y="1752600"/>
              <a:ext cx="4556064" cy="396240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657600" y="2209800"/>
              <a:ext cx="561372" cy="9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400" dirty="0"/>
                <a:t>B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891583" y="2209800"/>
              <a:ext cx="585417" cy="9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400" dirty="0" smtClean="0"/>
                <a:t>A</a:t>
              </a:r>
              <a:endParaRPr lang="en-GB" sz="54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637643" y="4114800"/>
              <a:ext cx="553357" cy="9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400" dirty="0" smtClean="0"/>
                <a:t>C</a:t>
              </a:r>
              <a:endParaRPr lang="en-GB" sz="54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865935" y="4114800"/>
              <a:ext cx="611065" cy="9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400" dirty="0"/>
                <a:t>D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 rot="16200000">
              <a:off x="612262" y="3443330"/>
              <a:ext cx="24976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Individual characteristics</a:t>
              </a:r>
              <a:endParaRPr lang="en-GB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868646" y="6183868"/>
              <a:ext cx="23797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Sexual partner network</a:t>
              </a:r>
              <a:endParaRPr lang="en-GB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667000" y="579120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0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286000" y="5421868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0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286000" y="1688068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5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7013514" y="579120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65583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29</Words>
  <Application>Microsoft Office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Additional file 4: data synthesis matrix  modified from Hogarth R M (2005) The challenge of representative design in psychology and economics. Journal of economic Methodology, 12(2): 253-263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ampiero</dc:creator>
  <cp:lastModifiedBy>Favato, Giampiero</cp:lastModifiedBy>
  <cp:revision>11</cp:revision>
  <dcterms:created xsi:type="dcterms:W3CDTF">2016-02-26T14:19:17Z</dcterms:created>
  <dcterms:modified xsi:type="dcterms:W3CDTF">2016-03-18T20:28:09Z</dcterms:modified>
</cp:coreProperties>
</file>